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  <p:sldId id="258" r:id="rId4"/>
    <p:sldId id="259" r:id="rId5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752" autoAdjust="0"/>
    <p:restoredTop sz="94660"/>
  </p:normalViewPr>
  <p:slideViewPr>
    <p:cSldViewPr snapToGrid="0">
      <p:cViewPr varScale="1">
        <p:scale>
          <a:sx n="72" d="100"/>
          <a:sy n="72" d="100"/>
        </p:scale>
        <p:origin x="2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845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60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753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07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759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047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964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901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58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557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72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5929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3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538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6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2591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9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73356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2268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2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3912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112</Words>
  <Application>Microsoft Office PowerPoint</Application>
  <PresentationFormat>A4 210 x 297 mm</PresentationFormat>
  <Paragraphs>3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　幸二</dc:creator>
  <cp:lastModifiedBy>門田　幸二</cp:lastModifiedBy>
  <cp:revision>42</cp:revision>
  <dcterms:created xsi:type="dcterms:W3CDTF">2020-06-11T23:59:28Z</dcterms:created>
  <dcterms:modified xsi:type="dcterms:W3CDTF">2020-07-27T00:35:46Z</dcterms:modified>
</cp:coreProperties>
</file>